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3" d="100"/>
          <a:sy n="73" d="100"/>
        </p:scale>
        <p:origin x="381" y="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8907DEE-4D54-4470-A71A-2867CBE1D9B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97B8D6DE-FDBA-4B3C-ACBA-8F69829B6AE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CF3B5B5-DEB7-4ED0-8701-89EB8887A6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8C5A2A-2FD0-4147-A77F-33A8C73E922A}" type="datetimeFigureOut">
              <a:rPr lang="zh-CN" altLang="en-US" smtClean="0"/>
              <a:t>2021/12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23792A6-103D-43F7-ABA7-E8E4478F6A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19C1200-2B11-43F5-B477-37CCE68A56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1C213-1A31-41C5-8A8B-CBF71C03CD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705764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0112C19-0FCC-47A1-91C6-767349A713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39377725-A2E6-4258-BFFF-A9358745198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F42EC9B-C8AA-43CA-AE1F-CAF7364C43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8C5A2A-2FD0-4147-A77F-33A8C73E922A}" type="datetimeFigureOut">
              <a:rPr lang="zh-CN" altLang="en-US" smtClean="0"/>
              <a:t>2021/12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D3A0DD8-E0CC-4AE3-9FD4-F7EBD6D96F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D8CB810-C161-493A-989B-E2BAA4C2E6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1C213-1A31-41C5-8A8B-CBF71C03CD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89812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7A6785B8-5ABD-4A2B-B52C-769CA7E68A4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E575DA7-2600-4A08-9B75-092E1DABEFC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7CFA2F0-1D41-45B2-A183-C2F738296A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8C5A2A-2FD0-4147-A77F-33A8C73E922A}" type="datetimeFigureOut">
              <a:rPr lang="zh-CN" altLang="en-US" smtClean="0"/>
              <a:t>2021/12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C168884-F2D5-4B4A-BCE4-9593E43EE7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F8F96A9-F5B1-430E-BA8F-B3F9FB36A7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1C213-1A31-41C5-8A8B-CBF71C03CD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04609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1B4A631-377B-4023-A210-BFD5A924E8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59B77AA-AC8A-43EF-9162-E5B7193EB18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284ED20-2909-40BF-AA9F-A7644875F1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8C5A2A-2FD0-4147-A77F-33A8C73E922A}" type="datetimeFigureOut">
              <a:rPr lang="zh-CN" altLang="en-US" smtClean="0"/>
              <a:t>2021/12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CCBDDBD-43EC-4784-85BD-4BA5014C5B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33643D5-FC6F-412E-A7BA-A7D0A77525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1C213-1A31-41C5-8A8B-CBF71C03CD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62908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6684DF3-44DE-4CFD-B553-562B65BF69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01A6592-5472-42FF-A5E3-145DC33AD7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34BE119-4D01-45B5-9F50-003B4F1D8B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8C5A2A-2FD0-4147-A77F-33A8C73E922A}" type="datetimeFigureOut">
              <a:rPr lang="zh-CN" altLang="en-US" smtClean="0"/>
              <a:t>2021/12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13A7080-0129-4FAE-A22E-94D8499A88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245646B-AF0D-4BF5-AA38-C9BDD9626F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1C213-1A31-41C5-8A8B-CBF71C03CD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265577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C353FD4-D95A-4332-B70B-6D459261E9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5291745-4E3F-489C-B32F-F5DD96FF811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F456FC1-C716-4DCE-A29F-440B9936C28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1B6C7CC-D7E8-4853-92D2-53D7BAED46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8C5A2A-2FD0-4147-A77F-33A8C73E922A}" type="datetimeFigureOut">
              <a:rPr lang="zh-CN" altLang="en-US" smtClean="0"/>
              <a:t>2021/12/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C3441D9-A2F1-40DE-B272-1EA7D44809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DC47FDB-7B26-467C-B9EA-0C85901975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1C213-1A31-41C5-8A8B-CBF71C03CD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505158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2CEAE72-FF10-48A4-BC87-197E845191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A8D742C-72C9-4FEC-9A38-1B6DCC5442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C9A4BBA-CBD0-4A09-97F1-C00ADF9A550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C5CE236D-2C9C-48B1-9B27-056639BD146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C58B5E97-6451-4A77-8024-E2C0368C029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E04B9123-6C80-4903-AAAB-740E00414A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8C5A2A-2FD0-4147-A77F-33A8C73E922A}" type="datetimeFigureOut">
              <a:rPr lang="zh-CN" altLang="en-US" smtClean="0"/>
              <a:t>2021/12/1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55D19CFC-CF25-449F-9BF0-CBE8B53F47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A9580970-2813-4AE1-B563-452AD30741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1C213-1A31-41C5-8A8B-CBF71C03CD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48821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ACC8FC0-4716-4663-BA15-89BBDD0CE1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A96CC621-89C1-41A4-88F8-628D1A6908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8C5A2A-2FD0-4147-A77F-33A8C73E922A}" type="datetimeFigureOut">
              <a:rPr lang="zh-CN" altLang="en-US" smtClean="0"/>
              <a:t>2021/12/1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5783C52A-B3F9-4C06-B9AC-F51ED1CAE7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BBA3DD19-0956-4228-B334-9AC9A169BD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1C213-1A31-41C5-8A8B-CBF71C03CD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599246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17E83355-A1ED-45C7-92D8-6B1FC56D48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8C5A2A-2FD0-4147-A77F-33A8C73E922A}" type="datetimeFigureOut">
              <a:rPr lang="zh-CN" altLang="en-US" smtClean="0"/>
              <a:t>2021/12/1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A75A8CC0-946B-4DDB-BD83-8CF613DC93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6EE00D52-FD32-4495-B004-F359F9A945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1C213-1A31-41C5-8A8B-CBF71C03CD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2953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ED572A4-080F-486C-8899-8FFA5B3C69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8632828-66B2-493B-B383-8B5C32A2A96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CF3F9FA-EB45-4064-A8F9-614BC2CFBC7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416F9EA-232B-4AB3-8BD7-3F3B64312C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8C5A2A-2FD0-4147-A77F-33A8C73E922A}" type="datetimeFigureOut">
              <a:rPr lang="zh-CN" altLang="en-US" smtClean="0"/>
              <a:t>2021/12/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F7CF8DA-E00E-4917-989C-3B0105C71F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87158CC-E4B7-4F31-91BE-915D1CDA2E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1C213-1A31-41C5-8A8B-CBF71C03CD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11855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9A61E7B-EEBB-42CC-9E61-7690D982C2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618EAF59-7587-48B5-8A13-D3EE4DC91F3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0905A29-1617-4D3C-B4B6-06E845A60A8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67938F1-A174-47D6-9991-42178B4CD8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8C5A2A-2FD0-4147-A77F-33A8C73E922A}" type="datetimeFigureOut">
              <a:rPr lang="zh-CN" altLang="en-US" smtClean="0"/>
              <a:t>2021/12/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7D6D124-4FB7-41DC-9BB1-27C09DD2CA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8063038-FB5E-42E1-9D1D-DB31B89586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1C213-1A31-41C5-8A8B-CBF71C03CD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58068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0A399144-E2FA-40F9-B828-9DB3406265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3BE33D8-F595-4FE1-90C8-A7E27F077A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22DD1F0-71F5-4B94-9F9D-9396F996E4E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8C5A2A-2FD0-4147-A77F-33A8C73E922A}" type="datetimeFigureOut">
              <a:rPr lang="zh-CN" altLang="en-US" smtClean="0"/>
              <a:t>2021/12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CE7B633-E12F-4A98-B1E7-7EF8C38E65B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6541619-6250-44A4-AA63-3DB30A3068B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91C213-1A31-41C5-8A8B-CBF71C03CD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23461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DFE7744-AD08-488E-8AF7-B9E8EE108F16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altLang="zh-CN" dirty="0"/>
              <a:t>DHE staining</a:t>
            </a:r>
            <a:endParaRPr lang="zh-CN" altLang="en-US" dirty="0"/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D3EF740C-3A6B-42C4-9CEF-2DE006EBF417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altLang="zh-CN" dirty="0"/>
              <a:t>These images were shown in Figure 5B</a:t>
            </a:r>
            <a:endParaRPr lang="zh-CN" altLang="en-US" dirty="0"/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5495486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4E0961EE-1A93-40CC-8B99-1C89869E2D38}"/>
              </a:ext>
            </a:extLst>
          </p:cNvPr>
          <p:cNvSpPr txBox="1"/>
          <p:nvPr/>
        </p:nvSpPr>
        <p:spPr>
          <a:xfrm>
            <a:off x="0" y="166283"/>
            <a:ext cx="152483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LPS-DHE</a:t>
            </a:r>
            <a:endParaRPr lang="zh-CN" altLang="en-US" dirty="0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34B78BCD-CC12-4ADA-9660-B9A46C8B3D7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7432" y="0"/>
            <a:ext cx="9117136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802552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BA756620-0635-44C1-A4D3-0C2EFA0D69A7}"/>
              </a:ext>
            </a:extLst>
          </p:cNvPr>
          <p:cNvSpPr txBox="1"/>
          <p:nvPr/>
        </p:nvSpPr>
        <p:spPr>
          <a:xfrm>
            <a:off x="0" y="166283"/>
            <a:ext cx="152483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LPS</a:t>
            </a:r>
            <a:r>
              <a:rPr lang="zh-CN" altLang="en-US" dirty="0"/>
              <a:t>-</a:t>
            </a:r>
            <a:r>
              <a:rPr lang="en-US" altLang="zh-CN" dirty="0"/>
              <a:t>DAPI</a:t>
            </a:r>
            <a:endParaRPr lang="zh-CN" altLang="en-US" dirty="0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2B04FEDC-AA8B-4E3A-B2DC-0BCFF4C6DE9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7432" y="0"/>
            <a:ext cx="9117136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923671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6BEA5FA9-B261-4F86-BD41-90B964BADB37}"/>
              </a:ext>
            </a:extLst>
          </p:cNvPr>
          <p:cNvSpPr txBox="1"/>
          <p:nvPr/>
        </p:nvSpPr>
        <p:spPr>
          <a:xfrm>
            <a:off x="0" y="166283"/>
            <a:ext cx="152483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LPS</a:t>
            </a:r>
            <a:r>
              <a:rPr lang="zh-CN" altLang="en-US" dirty="0"/>
              <a:t>-</a:t>
            </a:r>
            <a:r>
              <a:rPr lang="en-US" altLang="zh-CN" dirty="0"/>
              <a:t>merge</a:t>
            </a:r>
            <a:endParaRPr lang="zh-CN" altLang="en-US" dirty="0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9468CA6D-AC5D-455C-A0AC-8F7E473A3F1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7432" y="0"/>
            <a:ext cx="9117136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716985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</TotalTime>
  <Words>16</Words>
  <Application>Microsoft Office PowerPoint</Application>
  <PresentationFormat>宽屏</PresentationFormat>
  <Paragraphs>5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8" baseType="lpstr">
      <vt:lpstr>等线</vt:lpstr>
      <vt:lpstr>等线 Light</vt:lpstr>
      <vt:lpstr>Arial</vt:lpstr>
      <vt:lpstr>Office 主题​​</vt:lpstr>
      <vt:lpstr>DHE staining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HE staining</dc:title>
  <dc:creator>ruan weibin</dc:creator>
  <cp:lastModifiedBy>ruan weibin</cp:lastModifiedBy>
  <cp:revision>2</cp:revision>
  <dcterms:created xsi:type="dcterms:W3CDTF">2021-10-12T02:28:54Z</dcterms:created>
  <dcterms:modified xsi:type="dcterms:W3CDTF">2021-12-01T11:34:17Z</dcterms:modified>
</cp:coreProperties>
</file>